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30C8C-38E7-4E9D-80D8-83B5EBC062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F42CF-2A20-4ED3-BD1B-1C86878EE8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97F81-518E-486D-B546-BBF7EE09F9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DDAD4-06FE-45AA-858C-867DF3BF70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FDDD2-B2C6-4C63-9BC3-DEEE35320E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B40D0-B5B5-42C8-B1F2-8B60F6E1FE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94149-89CE-4D3B-AB87-CBED807268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4B6EC-6EE9-4B74-8500-451851D851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8F40A-2657-44C9-8BE7-41F92F0FF6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F8D59-B092-4A34-8121-2DF0CEA85D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53B44-AF6E-4047-8B3B-4C3B5C5F01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16D04-F6C1-4DA8-A3F6-C6F59BA9AA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D57AA1-E0DA-48F1-94C2-46CF9C63723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o 3"/>
          <p:cNvGrpSpPr/>
          <p:nvPr/>
        </p:nvGrpSpPr>
        <p:grpSpPr>
          <a:xfrm>
            <a:off x="1897200" y="1438200"/>
            <a:ext cx="5349600" cy="3980880"/>
            <a:chOff x="1897200" y="1438200"/>
            <a:chExt cx="5349600" cy="3980880"/>
          </a:xfrm>
        </p:grpSpPr>
        <p:pic>
          <p:nvPicPr>
            <p:cNvPr id="42" name="Chart 1" descr=""/>
            <p:cNvPicPr/>
            <p:nvPr/>
          </p:nvPicPr>
          <p:blipFill>
            <a:blip r:embed="rId1"/>
            <a:stretch/>
          </p:blipFill>
          <p:spPr>
            <a:xfrm>
              <a:off x="1897200" y="1438200"/>
              <a:ext cx="5349600" cy="3719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6"/>
            <p:cNvSpPr/>
            <p:nvPr/>
          </p:nvSpPr>
          <p:spPr>
            <a:xfrm>
              <a:off x="4660200" y="5157720"/>
              <a:ext cx="1274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1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-log10 (</a:t>
              </a:r>
              <a:r>
                <a:rPr b="0" i="1" lang="pt-BR" sz="11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P</a:t>
              </a:r>
              <a:r>
                <a:rPr b="0" lang="pt-BR" sz="11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-value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4" name="CaixaDeTexto 2"/>
          <p:cNvSpPr/>
          <p:nvPr/>
        </p:nvSpPr>
        <p:spPr>
          <a:xfrm>
            <a:off x="307800" y="237960"/>
            <a:ext cx="135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dditional Figur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"/>
          <p:cNvSpPr/>
          <p:nvPr/>
        </p:nvSpPr>
        <p:spPr>
          <a:xfrm>
            <a:off x="755640" y="6095880"/>
            <a:ext cx="8291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MS PGothic"/>
              </a:rPr>
              <a:t>Additional Figure 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PGothic"/>
              </a:rPr>
              <a:t> - Top 10 significantly mutated pathways in oral tongue squamous cell carcinoma (OTSCC), as determined by examination of the Molecula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PGothic"/>
              </a:rPr>
              <a:t>Signatures Database (MSigDB) by Gene Set Enrichment Analysis (GSEA) software and comparisons with well-recognized cancer-related pathways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9T08:19:54Z</dcterms:created>
  <dc:creator>HP</dc:creator>
  <dc:description/>
  <dc:language>en-US</dc:language>
  <cp:lastModifiedBy>N.Gopalakrishna Iyer</cp:lastModifiedBy>
  <dcterms:modified xsi:type="dcterms:W3CDTF">2015-07-15T02:49:58Z</dcterms:modified>
  <cp:revision>3</cp:revision>
  <dc:subject/>
  <dc:title>Apresentação do PowerPoint</dc:title>
</cp:coreProperties>
</file>